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 bookmarkIdSeed="4">
  <p:sldMasterIdLst>
    <p:sldMasterId id="2147483670" r:id="rId1"/>
    <p:sldMasterId id="2147483680" r:id="rId2"/>
  </p:sldMasterIdLst>
  <p:notesMasterIdLst>
    <p:notesMasterId r:id="rId7"/>
  </p:notesMasterIdLst>
  <p:sldIdLst>
    <p:sldId id="366" r:id="rId3"/>
    <p:sldId id="347" r:id="rId4"/>
    <p:sldId id="384" r:id="rId5"/>
    <p:sldId id="424" r:id="rId6"/>
  </p:sldIdLst>
  <p:sldSz cx="9144000" cy="5143500" type="screen16x9"/>
  <p:notesSz cx="6858000" cy="9144000"/>
  <p:embeddedFontLst>
    <p:embeddedFont>
      <p:font typeface="Calibri" panose="020F0502020204030204" pitchFamily="34" charset="0"/>
      <p:regular r:id="rId8"/>
      <p:bold r:id="rId9"/>
      <p:italic r:id="rId10"/>
      <p:boldItalic r:id="rId11"/>
    </p:embeddedFont>
    <p:embeddedFont>
      <p:font typeface="Calibri Light" panose="020F0302020204030204" pitchFamily="34" charset="0"/>
      <p:regular r:id="rId12"/>
      <p:italic r:id="rId13"/>
    </p:embeddedFont>
    <p:embeddedFont>
      <p:font typeface="Inter" panose="020B0604020202020204" charset="0"/>
      <p:regular r:id="rId14"/>
      <p:bold r:id="rId15"/>
    </p:embeddedFont>
    <p:embeddedFont>
      <p:font typeface="Lato" panose="020F0502020204030203" pitchFamily="34" charset="0"/>
      <p:regular r:id="rId16"/>
      <p:bold r:id="rId17"/>
      <p:italic r:id="rId18"/>
      <p:boldItalic r:id="rId1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cDonough, Liz (GE Research, US)" initials="ML(RU" lastIdx="3" clrIdx="0">
    <p:extLst>
      <p:ext uri="{19B8F6BF-5375-455C-9EA6-DF929625EA0E}">
        <p15:presenceInfo xmlns:p15="http://schemas.microsoft.com/office/powerpoint/2012/main" userId="S::200020245@ge.com::65e63c4a-bae3-4d29-b16a-5fb24d18720b" providerId="AD"/>
      </p:ext>
    </p:extLst>
  </p:cmAuthor>
  <p:cmAuthor id="2" name="Ginty, Fiona (GE Research, US)" initials="GF(RU" lastIdx="24" clrIdx="1">
    <p:extLst>
      <p:ext uri="{19B8F6BF-5375-455C-9EA6-DF929625EA0E}">
        <p15:presenceInfo xmlns:p15="http://schemas.microsoft.com/office/powerpoint/2012/main" userId="S::200013327@ge.com::d86cdd37-b2e0-458b-85d0-348a715d9160" providerId="AD"/>
      </p:ext>
    </p:extLst>
  </p:cmAuthor>
  <p:cmAuthor id="3" name="Elizabeth McDonough" initials="EM" lastIdx="1" clrIdx="2">
    <p:extLst>
      <p:ext uri="{19B8F6BF-5375-455C-9EA6-DF929625EA0E}">
        <p15:presenceInfo xmlns:p15="http://schemas.microsoft.com/office/powerpoint/2012/main" userId="edsNRFnmzxuonv8yn68d8/kkzDoHlZwt3fIxD5Gu8to=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29ED13"/>
    <a:srgbClr val="79F8FB"/>
    <a:srgbClr val="BF22D4"/>
    <a:srgbClr val="050507"/>
    <a:srgbClr val="C089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250" autoAdjust="0"/>
    <p:restoredTop sz="86288" autoAdjust="0"/>
  </p:normalViewPr>
  <p:slideViewPr>
    <p:cSldViewPr snapToGrid="0">
      <p:cViewPr varScale="1">
        <p:scale>
          <a:sx n="77" d="100"/>
          <a:sy n="77" d="100"/>
        </p:scale>
        <p:origin x="258" y="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1.fntdata"/><Relationship Id="rId13" Type="http://schemas.openxmlformats.org/officeDocument/2006/relationships/font" Target="fonts/font6.fntdata"/><Relationship Id="rId18" Type="http://schemas.openxmlformats.org/officeDocument/2006/relationships/font" Target="fonts/font11.fntdata"/><Relationship Id="rId3" Type="http://schemas.openxmlformats.org/officeDocument/2006/relationships/slide" Target="slides/slide1.xml"/><Relationship Id="rId21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12" Type="http://schemas.openxmlformats.org/officeDocument/2006/relationships/font" Target="fonts/font5.fntdata"/><Relationship Id="rId17" Type="http://schemas.openxmlformats.org/officeDocument/2006/relationships/font" Target="fonts/font10.fntdata"/><Relationship Id="rId2" Type="http://schemas.openxmlformats.org/officeDocument/2006/relationships/slideMaster" Target="slideMasters/slideMaster2.xml"/><Relationship Id="rId16" Type="http://schemas.openxmlformats.org/officeDocument/2006/relationships/font" Target="fonts/font9.fntdata"/><Relationship Id="rId20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font" Target="fonts/font4.fntdata"/><Relationship Id="rId24" Type="http://schemas.openxmlformats.org/officeDocument/2006/relationships/tableStyles" Target="tableStyles.xml"/><Relationship Id="rId5" Type="http://schemas.openxmlformats.org/officeDocument/2006/relationships/slide" Target="slides/slide3.xml"/><Relationship Id="rId15" Type="http://schemas.openxmlformats.org/officeDocument/2006/relationships/font" Target="fonts/font8.fntdata"/><Relationship Id="rId23" Type="http://schemas.openxmlformats.org/officeDocument/2006/relationships/theme" Target="theme/theme1.xml"/><Relationship Id="rId10" Type="http://schemas.openxmlformats.org/officeDocument/2006/relationships/font" Target="fonts/font3.fntdata"/><Relationship Id="rId19" Type="http://schemas.openxmlformats.org/officeDocument/2006/relationships/font" Target="fonts/font12.fntdata"/><Relationship Id="rId4" Type="http://schemas.openxmlformats.org/officeDocument/2006/relationships/slide" Target="slides/slide2.xml"/><Relationship Id="rId9" Type="http://schemas.openxmlformats.org/officeDocument/2006/relationships/font" Target="fonts/font2.fntdata"/><Relationship Id="rId14" Type="http://schemas.openxmlformats.org/officeDocument/2006/relationships/font" Target="fonts/font7.fntdata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3970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4987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dirty="0"/>
              <a:t>Title Only Layout</a:t>
            </a:r>
            <a:endParaRPr lang="en-CA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9EBFE-5BA1-460F-BE92-8CF5579A714B}" type="datetime4">
              <a:rPr lang="en-US" smtClean="0"/>
              <a:t>March 28, 202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166DF8EC-6E18-499F-B24E-A023426EF117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4883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272F5-91C4-439B-A4B0-CA8B94233A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76818C-4FF7-4704-9BE9-E83FCF00AD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5FC731-C9A3-4501-A12B-63D68681E0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0F66B7-9C87-4FB2-A0BC-F93ACB86A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DE0DE3-4096-47A7-AD1C-37A600802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F85E85-7447-4B8B-8374-0E440064A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756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D1CF93-3F2D-41A7-9B84-DD3E26CF0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97E097-9CB3-4DEF-83CD-B67A5DD696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B29251-45D3-46BC-8E33-403217F517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2E62CA3-95AD-48DE-954D-A15D7B973B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063224-79A7-4983-8C49-F26DDD59FF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E12394-1055-4065-8D31-51A44D862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F85BCD-5FD9-476F-9DF9-06952ABB4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667117-EDA3-47E1-AAFE-E1BF1F2A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4830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D7F2D-529A-411A-A5C3-95E7FD0F9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C6C0EF-EFAE-4BE6-A125-A92D01DAA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4E7041-FDAB-42A4-AB1E-9438E0D75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B326D7-12BD-47CE-9F3E-90F5C672C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45886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F10484-C5C8-4E11-B67B-AC14D9FCA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7DDE10-1A76-4889-B79D-0EFD53899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B13D68-1AC3-4C12-8888-7F3964EBE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72106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38FE1-B87F-4D76-B9C4-5AD89BD60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E80787-3410-40B5-8546-AC6D0173AA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5DF62E-8C16-475C-97D3-178ED36050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34A6B1-527A-4DA7-8C97-C6830751D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756363-3C60-4B4C-952A-17E158E08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ECF887-5D7B-4092-A040-DC76CF05D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69812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28319-4AF1-4F4A-A05A-76501456E9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5ED8BF2-5F61-4B5B-9E25-789943EB64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14A308-DB1A-47A8-B675-F6E4951C7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9F6769-C526-4B71-8BDC-20ECEA93D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F55EEF-5D4B-4580-8752-D9525F7B1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4476B9-ADDA-45A5-8A35-0CB42D1EB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1796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461A7-5B6B-49CF-B77C-3E1B31D86D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07723B-89C3-4BD5-BFE5-725B77827F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B0833-3992-4B92-A269-E34A14BF3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205FDC-F0AB-48C5-AE10-2DD5C1BBB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855A34-7662-426F-B145-718F3AB2E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7967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595895E-6753-4E17-9924-131EF90548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38DA02-73B1-4BE6-8C83-8DD78D1554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C01B1-3757-4039-B387-F64BA8878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AE6816-250E-44B6-80D8-413C6508A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03F678-DBE7-436F-97B7-339A39B43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73964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220391" y="164592"/>
            <a:ext cx="6748272" cy="685800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Title and Content Layout</a:t>
            </a:r>
            <a:endParaRPr lang="en-CA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A7FD2-EEE1-4653-A3ED-EC06E26685F5}" type="datetime4">
              <a:rPr lang="en-US" smtClean="0"/>
              <a:t>March 28, 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8" name="Straight Connector 7"/>
          <p:cNvCxnSpPr/>
          <p:nvPr/>
        </p:nvCxnSpPr>
        <p:spPr>
          <a:xfrm>
            <a:off x="2063353" y="1235441"/>
            <a:ext cx="6747272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chemeClr val="accent1">
                    <a:tint val="44500"/>
                    <a:satMod val="160000"/>
                  </a:schemeClr>
                </a:gs>
                <a:gs pos="100000">
                  <a:schemeClr val="accent1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1220391" y="850392"/>
            <a:ext cx="6753225" cy="253746"/>
          </a:xfrm>
        </p:spPr>
        <p:txBody>
          <a:bodyPr anchor="b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1050" b="1"/>
            </a:lvl1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4"/>
          </p:nvPr>
        </p:nvSpPr>
        <p:spPr>
          <a:xfrm>
            <a:off x="1220391" y="1385316"/>
            <a:ext cx="6753225" cy="32575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 dirty="0"/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1220391" y="1235441"/>
            <a:ext cx="7590234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rgbClr val="B7E6FF"/>
                </a:gs>
                <a:gs pos="100000">
                  <a:schemeClr val="accent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910200-1FDA-45B7-8617-DD2A8D1CF6BD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8575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220391" y="164592"/>
            <a:ext cx="6748272" cy="685800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Title and Content Layout</a:t>
            </a:r>
            <a:endParaRPr lang="en-CA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A7FD2-EEE1-4653-A3ED-EC06E26685F5}" type="datetime4">
              <a:rPr lang="en-US" smtClean="0"/>
              <a:t>March 28, 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8" name="Straight Connector 7"/>
          <p:cNvCxnSpPr/>
          <p:nvPr/>
        </p:nvCxnSpPr>
        <p:spPr>
          <a:xfrm>
            <a:off x="2063353" y="1235441"/>
            <a:ext cx="6747272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chemeClr val="accent1">
                    <a:tint val="44500"/>
                    <a:satMod val="160000"/>
                  </a:schemeClr>
                </a:gs>
                <a:gs pos="100000">
                  <a:schemeClr val="accent1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1220391" y="850392"/>
            <a:ext cx="6753225" cy="253746"/>
          </a:xfrm>
        </p:spPr>
        <p:txBody>
          <a:bodyPr anchor="b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1050" b="1"/>
            </a:lvl1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4"/>
          </p:nvPr>
        </p:nvSpPr>
        <p:spPr>
          <a:xfrm>
            <a:off x="1220391" y="1385316"/>
            <a:ext cx="6753225" cy="32575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 dirty="0"/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1220391" y="1235441"/>
            <a:ext cx="7590234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rgbClr val="B7E6FF"/>
                </a:gs>
                <a:gs pos="100000">
                  <a:schemeClr val="accent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910200-1FDA-45B7-8617-DD2A8D1CF6BD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6811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5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220391" y="164592"/>
            <a:ext cx="6748272" cy="685800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Title and Content Layout</a:t>
            </a:r>
            <a:endParaRPr lang="en-CA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A7FD2-EEE1-4653-A3ED-EC06E26685F5}" type="datetime4">
              <a:rPr lang="en-US" smtClean="0"/>
              <a:t>March 28, 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8" name="Straight Connector 7"/>
          <p:cNvCxnSpPr/>
          <p:nvPr/>
        </p:nvCxnSpPr>
        <p:spPr>
          <a:xfrm>
            <a:off x="2063353" y="1235441"/>
            <a:ext cx="6747272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chemeClr val="accent1">
                    <a:tint val="44500"/>
                    <a:satMod val="160000"/>
                  </a:schemeClr>
                </a:gs>
                <a:gs pos="100000">
                  <a:schemeClr val="accent1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1220391" y="850392"/>
            <a:ext cx="6753225" cy="253746"/>
          </a:xfrm>
        </p:spPr>
        <p:txBody>
          <a:bodyPr anchor="b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1050" b="1"/>
            </a:lvl1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4"/>
          </p:nvPr>
        </p:nvSpPr>
        <p:spPr>
          <a:xfrm>
            <a:off x="1220391" y="1385316"/>
            <a:ext cx="6753225" cy="32575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 dirty="0"/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1220391" y="1235441"/>
            <a:ext cx="7590234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rgbClr val="B7E6FF"/>
                </a:gs>
                <a:gs pos="100000">
                  <a:schemeClr val="accent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910200-1FDA-45B7-8617-DD2A8D1CF6BD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43522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6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220391" y="164592"/>
            <a:ext cx="6748272" cy="685800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Title and Content Layout</a:t>
            </a:r>
            <a:endParaRPr lang="en-CA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A7FD2-EEE1-4653-A3ED-EC06E26685F5}" type="datetime4">
              <a:rPr lang="en-US" smtClean="0"/>
              <a:t>March 28, 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8" name="Straight Connector 7"/>
          <p:cNvCxnSpPr/>
          <p:nvPr/>
        </p:nvCxnSpPr>
        <p:spPr>
          <a:xfrm>
            <a:off x="2063353" y="1235441"/>
            <a:ext cx="6747272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chemeClr val="accent1">
                    <a:tint val="44500"/>
                    <a:satMod val="160000"/>
                  </a:schemeClr>
                </a:gs>
                <a:gs pos="100000">
                  <a:schemeClr val="accent1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1220391" y="850392"/>
            <a:ext cx="6753225" cy="253746"/>
          </a:xfrm>
        </p:spPr>
        <p:txBody>
          <a:bodyPr anchor="b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1050" b="1"/>
            </a:lvl1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4"/>
          </p:nvPr>
        </p:nvSpPr>
        <p:spPr>
          <a:xfrm>
            <a:off x="1220391" y="1385316"/>
            <a:ext cx="6753225" cy="32575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 dirty="0"/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1220391" y="1235441"/>
            <a:ext cx="7590234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rgbClr val="B7E6FF"/>
                </a:gs>
                <a:gs pos="100000">
                  <a:schemeClr val="accent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910200-1FDA-45B7-8617-DD2A8D1CF6BD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73836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220391" y="164592"/>
            <a:ext cx="6748272" cy="685800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Title and Content Layout</a:t>
            </a:r>
            <a:endParaRPr lang="en-CA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A7FD2-EEE1-4653-A3ED-EC06E26685F5}" type="datetime4">
              <a:rPr lang="en-US" smtClean="0"/>
              <a:t>March 28, 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8" name="Straight Connector 7"/>
          <p:cNvCxnSpPr/>
          <p:nvPr/>
        </p:nvCxnSpPr>
        <p:spPr>
          <a:xfrm>
            <a:off x="2063353" y="1235441"/>
            <a:ext cx="6747272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chemeClr val="accent1">
                    <a:tint val="44500"/>
                    <a:satMod val="160000"/>
                  </a:schemeClr>
                </a:gs>
                <a:gs pos="100000">
                  <a:schemeClr val="accent1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1220391" y="850392"/>
            <a:ext cx="6753225" cy="253746"/>
          </a:xfrm>
        </p:spPr>
        <p:txBody>
          <a:bodyPr anchor="b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1050" b="1"/>
            </a:lvl1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4"/>
          </p:nvPr>
        </p:nvSpPr>
        <p:spPr>
          <a:xfrm>
            <a:off x="1220391" y="1385316"/>
            <a:ext cx="6753225" cy="32575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 dirty="0"/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1220391" y="1235441"/>
            <a:ext cx="7590234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rgbClr val="B7E6FF"/>
                </a:gs>
                <a:gs pos="100000">
                  <a:schemeClr val="accent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910200-1FDA-45B7-8617-DD2A8D1CF6BD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0101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220391" y="164592"/>
            <a:ext cx="6748272" cy="685800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Title and Content Layout</a:t>
            </a:r>
            <a:endParaRPr lang="en-CA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A7FD2-EEE1-4653-A3ED-EC06E26685F5}" type="datetime4">
              <a:rPr lang="en-US" smtClean="0"/>
              <a:t>March 28, 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/>
              <a:t>Presentation Titl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‹#›</a:t>
            </a:fld>
            <a:endParaRPr lang="en-CA"/>
          </a:p>
        </p:txBody>
      </p:sp>
      <p:cxnSp>
        <p:nvCxnSpPr>
          <p:cNvPr id="8" name="Straight Connector 7"/>
          <p:cNvCxnSpPr/>
          <p:nvPr/>
        </p:nvCxnSpPr>
        <p:spPr>
          <a:xfrm>
            <a:off x="2063353" y="1235441"/>
            <a:ext cx="6747272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chemeClr val="accent1">
                    <a:tint val="44500"/>
                    <a:satMod val="160000"/>
                  </a:schemeClr>
                </a:gs>
                <a:gs pos="100000">
                  <a:schemeClr val="accent1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1220391" y="850392"/>
            <a:ext cx="6753225" cy="253746"/>
          </a:xfrm>
        </p:spPr>
        <p:txBody>
          <a:bodyPr anchor="b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1050" b="1"/>
            </a:lvl1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4"/>
          </p:nvPr>
        </p:nvSpPr>
        <p:spPr>
          <a:xfrm>
            <a:off x="1220391" y="1385316"/>
            <a:ext cx="6753225" cy="32575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 dirty="0"/>
          </a:p>
        </p:txBody>
      </p:sp>
      <p:cxnSp>
        <p:nvCxnSpPr>
          <p:cNvPr id="10" name="Straight Connector 9"/>
          <p:cNvCxnSpPr/>
          <p:nvPr userDrawn="1"/>
        </p:nvCxnSpPr>
        <p:spPr>
          <a:xfrm>
            <a:off x="1220391" y="1235441"/>
            <a:ext cx="7590234" cy="0"/>
          </a:xfrm>
          <a:prstGeom prst="line">
            <a:avLst/>
          </a:prstGeom>
          <a:ln w="19050">
            <a:gradFill>
              <a:gsLst>
                <a:gs pos="0">
                  <a:schemeClr val="bg1"/>
                </a:gs>
                <a:gs pos="25000">
                  <a:srgbClr val="B7E6FF"/>
                </a:gs>
                <a:gs pos="100000">
                  <a:schemeClr val="accent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910200-1FDA-45B7-8617-DD2A8D1CF6BD}"/>
              </a:ext>
            </a:extLst>
          </p:cNvPr>
          <p:cNvCxnSpPr/>
          <p:nvPr userDrawn="1"/>
        </p:nvCxnSpPr>
        <p:spPr>
          <a:xfrm>
            <a:off x="1220391" y="4808247"/>
            <a:ext cx="7586805" cy="0"/>
          </a:xfrm>
          <a:prstGeom prst="line">
            <a:avLst/>
          </a:prstGeom>
          <a:ln w="31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9683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F83AF-B46C-4A8A-8070-515B806EB3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F7B95B-DEB0-4062-B6E7-8E7723A4C8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E609D3-CB41-4495-9360-492E13693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04505-470D-40CF-963C-BB5092E5A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23402-0C80-4895-8F2A-6078AE3E6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515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089C6-EF51-4AB9-BF05-5B36B01C6B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F1CE82-7DE3-4848-A5D0-23E6641E53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BBEB61-A1A7-4ED7-9150-5EBEDB85E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D2061D-89DE-43DE-BF9E-066675F1F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9E13C-556D-4D91-9251-D1A8CE8AB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699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E4FB15-A0A9-4F24-8319-DAE2164AF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82CCCE-88BB-45B0-AA88-829C59BA7F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DF235A-1F27-426F-8BA7-D6045338D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0DEA6-5F52-42EF-B450-C444D397B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ED329-BECD-47DE-BD34-E853F942A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452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4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9.xml"/><Relationship Id="rId7" Type="http://schemas.openxmlformats.org/officeDocument/2006/relationships/slideLayout" Target="../slideLayouts/slideLayout13.xml"/><Relationship Id="rId12" Type="http://schemas.openxmlformats.org/officeDocument/2006/relationships/slideLayout" Target="../slideLayouts/slideLayout18.xml"/><Relationship Id="rId2" Type="http://schemas.openxmlformats.org/officeDocument/2006/relationships/slideLayout" Target="../slideLayouts/slideLayout8.xml"/><Relationship Id="rId1" Type="http://schemas.openxmlformats.org/officeDocument/2006/relationships/slideLayout" Target="../slideLayouts/slideLayout7.xml"/><Relationship Id="rId6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0.xml"/><Relationship Id="rId9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wiss-2">
    <p:bg>
      <p:bgPr>
        <a:solidFill>
          <a:schemeClr val="lt1"/>
        </a:solidFill>
        <a:effectLst/>
      </p:bgPr>
    </p:bg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p17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Inter"/>
              <a:buNone/>
              <a:defRPr sz="30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Inter"/>
              <a:buChar char="●"/>
              <a:defRPr sz="18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○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■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●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○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■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●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Inter"/>
              <a:buChar char="○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Font typeface="Inter"/>
              <a:buChar char="■"/>
              <a:defRPr sz="1400" b="0" i="0" u="none" strike="noStrike" cap="none">
                <a:solidFill>
                  <a:schemeClr val="dk2"/>
                </a:solidFill>
                <a:latin typeface="Inter"/>
                <a:ea typeface="Inter"/>
                <a:cs typeface="Inter"/>
                <a:sym typeface="Inter"/>
              </a:defRPr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73" r:id="rId1"/>
    <p:sldLayoutId id="2147483675" r:id="rId2"/>
    <p:sldLayoutId id="2147483677" r:id="rId3"/>
    <p:sldLayoutId id="2147483678" r:id="rId4"/>
    <p:sldLayoutId id="2147483679" r:id="rId5"/>
    <p:sldLayoutId id="2147483692" r:id="rId6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C998F9-AA35-4837-BAB8-E00FFCC1FB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2E0B59-607C-427D-A8F2-F3C9F147E2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DF28B-D9D5-4FBA-BA99-8BF93DBF26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30427-59C9-4B9C-900F-FCCC3D79FEC4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B72550-C650-456C-9C5C-7F7753F072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EB2F0C-B184-43B1-8EC6-FFEADFF133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20CC2-C9E7-4450-8317-123419A63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86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1" r:id="rId1"/>
    <p:sldLayoutId id="2147483682" r:id="rId2"/>
    <p:sldLayoutId id="2147483683" r:id="rId3"/>
    <p:sldLayoutId id="2147483684" r:id="rId4"/>
    <p:sldLayoutId id="2147483685" r:id="rId5"/>
    <p:sldLayoutId id="2147483686" r:id="rId6"/>
    <p:sldLayoutId id="2147483687" r:id="rId7"/>
    <p:sldLayoutId id="2147483688" r:id="rId8"/>
    <p:sldLayoutId id="2147483689" r:id="rId9"/>
    <p:sldLayoutId id="2147483690" r:id="rId10"/>
    <p:sldLayoutId id="2147483691" r:id="rId11"/>
    <p:sldLayoutId id="2147483695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B000A-C4D7-4F9F-9A4A-346D435D06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2244" y="563424"/>
            <a:ext cx="7445208" cy="635400"/>
          </a:xfrm>
        </p:spPr>
        <p:txBody>
          <a:bodyPr/>
          <a:lstStyle/>
          <a:p>
            <a:r>
              <a:rPr lang="en-US" dirty="0">
                <a:solidFill>
                  <a:schemeClr val="bg1"/>
                </a:solidFill>
              </a:rPr>
              <a:t>Supplementary Tables</a:t>
            </a:r>
            <a:br>
              <a:rPr lang="en-US" dirty="0">
                <a:solidFill>
                  <a:schemeClr val="bg1"/>
                </a:solidFill>
              </a:rPr>
            </a:br>
            <a:br>
              <a:rPr lang="en-US" dirty="0">
                <a:solidFill>
                  <a:schemeClr val="bg1"/>
                </a:solidFill>
              </a:rPr>
            </a:br>
            <a:r>
              <a:rPr lang="en-US" sz="1400" dirty="0">
                <a:solidFill>
                  <a:schemeClr val="bg1"/>
                </a:solidFill>
                <a:latin typeface="+mj-lt"/>
              </a:rPr>
              <a:t>Ghose, Ju </a:t>
            </a:r>
            <a:r>
              <a:rPr lang="en-US" sz="1400" i="1" dirty="0">
                <a:solidFill>
                  <a:schemeClr val="bg1"/>
                </a:solidFill>
                <a:latin typeface="+mj-lt"/>
              </a:rPr>
              <a:t>et al </a:t>
            </a:r>
            <a:r>
              <a:rPr lang="en-US" sz="1400" kern="400" dirty="0">
                <a:solidFill>
                  <a:schemeClr val="bg1"/>
                </a:solidFill>
                <a:effectLst/>
                <a:latin typeface="+mj-lt"/>
                <a:ea typeface="Times New Roman" panose="02020603050405020304" pitchFamily="18" charset="0"/>
                <a:cs typeface="Calibri" panose="020F0502020204030204" pitchFamily="34" charset="0"/>
              </a:rPr>
              <a:t>Human Digital Twin: Automated Cell Type Distance Computation and 3D Atlas Construction in Multiplexed Skin Biopsies</a:t>
            </a:r>
            <a:endParaRPr lang="en-US" sz="1400" dirty="0">
              <a:solidFill>
                <a:schemeClr val="bg1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773542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2A23F0-479A-46C2-91BF-D2E3CFB2A76C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59299" y="138702"/>
            <a:ext cx="7937440" cy="635000"/>
          </a:xfrm>
        </p:spPr>
        <p:txBody>
          <a:bodyPr>
            <a:normAutofit/>
          </a:bodyPr>
          <a:lstStyle/>
          <a:p>
            <a:r>
              <a:rPr lang="en-US" sz="1000" b="1" dirty="0">
                <a:latin typeface="Calibri"/>
                <a:cs typeface="Calibri"/>
              </a:rPr>
              <a:t>Supplementary Table S1:  </a:t>
            </a:r>
            <a:r>
              <a:rPr lang="en-US" sz="1000" dirty="0">
                <a:latin typeface="Calibri"/>
                <a:cs typeface="Calibri"/>
              </a:rPr>
              <a:t>Patient summary and sample location </a:t>
            </a:r>
          </a:p>
        </p:txBody>
      </p:sp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6481C6E6-393A-41D8-98DD-78B5B4AA47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2814732"/>
              </p:ext>
            </p:extLst>
          </p:nvPr>
        </p:nvGraphicFramePr>
        <p:xfrm>
          <a:off x="291153" y="637199"/>
          <a:ext cx="8552655" cy="42483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4888">
                  <a:extLst>
                    <a:ext uri="{9D8B030D-6E8A-4147-A177-3AD203B41FA5}">
                      <a16:colId xmlns:a16="http://schemas.microsoft.com/office/drawing/2014/main" val="1759991026"/>
                    </a:ext>
                  </a:extLst>
                </a:gridCol>
                <a:gridCol w="648380">
                  <a:extLst>
                    <a:ext uri="{9D8B030D-6E8A-4147-A177-3AD203B41FA5}">
                      <a16:colId xmlns:a16="http://schemas.microsoft.com/office/drawing/2014/main" val="605662987"/>
                    </a:ext>
                  </a:extLst>
                </a:gridCol>
                <a:gridCol w="1539476">
                  <a:extLst>
                    <a:ext uri="{9D8B030D-6E8A-4147-A177-3AD203B41FA5}">
                      <a16:colId xmlns:a16="http://schemas.microsoft.com/office/drawing/2014/main" val="2866285928"/>
                    </a:ext>
                  </a:extLst>
                </a:gridCol>
                <a:gridCol w="1001863">
                  <a:extLst>
                    <a:ext uri="{9D8B030D-6E8A-4147-A177-3AD203B41FA5}">
                      <a16:colId xmlns:a16="http://schemas.microsoft.com/office/drawing/2014/main" val="3080998541"/>
                    </a:ext>
                  </a:extLst>
                </a:gridCol>
                <a:gridCol w="1222270">
                  <a:extLst>
                    <a:ext uri="{9D8B030D-6E8A-4147-A177-3AD203B41FA5}">
                      <a16:colId xmlns:a16="http://schemas.microsoft.com/office/drawing/2014/main" val="1836963445"/>
                    </a:ext>
                  </a:extLst>
                </a:gridCol>
                <a:gridCol w="712992">
                  <a:extLst>
                    <a:ext uri="{9D8B030D-6E8A-4147-A177-3AD203B41FA5}">
                      <a16:colId xmlns:a16="http://schemas.microsoft.com/office/drawing/2014/main" val="1666268035"/>
                    </a:ext>
                  </a:extLst>
                </a:gridCol>
                <a:gridCol w="363760">
                  <a:extLst>
                    <a:ext uri="{9D8B030D-6E8A-4147-A177-3AD203B41FA5}">
                      <a16:colId xmlns:a16="http://schemas.microsoft.com/office/drawing/2014/main" val="1329536780"/>
                    </a:ext>
                  </a:extLst>
                </a:gridCol>
                <a:gridCol w="625998">
                  <a:extLst>
                    <a:ext uri="{9D8B030D-6E8A-4147-A177-3AD203B41FA5}">
                      <a16:colId xmlns:a16="http://schemas.microsoft.com/office/drawing/2014/main" val="1514009457"/>
                    </a:ext>
                  </a:extLst>
                </a:gridCol>
                <a:gridCol w="688861">
                  <a:extLst>
                    <a:ext uri="{9D8B030D-6E8A-4147-A177-3AD203B41FA5}">
                      <a16:colId xmlns:a16="http://schemas.microsoft.com/office/drawing/2014/main" val="18521676"/>
                    </a:ext>
                  </a:extLst>
                </a:gridCol>
                <a:gridCol w="1054167">
                  <a:extLst>
                    <a:ext uri="{9D8B030D-6E8A-4147-A177-3AD203B41FA5}">
                      <a16:colId xmlns:a16="http://schemas.microsoft.com/office/drawing/2014/main" val="3848688713"/>
                    </a:ext>
                  </a:extLst>
                </a:gridCol>
              </a:tblGrid>
              <a:tr h="6349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onor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egion 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HuBMAP I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n exposure related damage by H&amp;E evaluation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ealth Status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Age (years)</a:t>
                      </a:r>
                      <a:endParaRPr lang="en-US" sz="1000" b="1" i="0" u="none" strike="noStrike" dirty="0"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Sex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Ethnicit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Tissue sit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+mn-lt"/>
                        </a:rPr>
                        <a:t>Dimensions (cm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2970895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372.JZTV.423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rke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 major illness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6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L distal upper ar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4.3 x 2.0 x 0.8 c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4060627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892.LCXT.493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rke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 illness;  HIV</a:t>
                      </a:r>
                      <a:endParaRPr lang="en-US" dirty="0"/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5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R ar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.7 x 2.4 x 0.5 c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902640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643.WWWB.264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rke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heumatoid Arthritis; </a:t>
                      </a:r>
                      <a:r>
                        <a:rPr lang="en-US" sz="1000" b="0" i="0" u="none" strike="noStrike" noProof="0" dirty="0">
                          <a:effectLst/>
                        </a:rPr>
                        <a:t>multiple SCC</a:t>
                      </a:r>
                      <a:endParaRPr lang="en-US" dirty="0"/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7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scal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2.8 x 1.1 x 0.7 c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2342998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 panose="020F0502020204030204" pitchFamily="34" charset="0"/>
                        </a:rPr>
                        <a:t>HBM262.JGDG.897</a:t>
                      </a:r>
                      <a:endParaRPr lang="en-US" sz="1050" dirty="0">
                        <a:effectLst/>
                        <a:latin typeface="Calibri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oderate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dirty="0"/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L distal lower le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.0 x 1.3 x 0.7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7659576"/>
                  </a:ext>
                </a:extLst>
              </a:tr>
              <a:tr h="2356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384.NNQH.676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arke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6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L lower ar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1.4 x 1.2 x 0.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541308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 panose="020F0502020204030204" pitchFamily="34" charset="0"/>
                        </a:rPr>
                        <a:t>HBM788.DGPQ.568</a:t>
                      </a:r>
                      <a:endParaRPr lang="en-US" sz="1050" dirty="0">
                        <a:effectLst/>
                        <a:latin typeface="Calibri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5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L lower mid back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.6 x 1.7 x 1.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8696683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875.KTPB.893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4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R upper ar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1.7 x 1.2 x 0.9 c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555851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 panose="020F0502020204030204" pitchFamily="34" charset="0"/>
                        </a:rPr>
                        <a:t>HBM579.CXHK.929</a:t>
                      </a:r>
                      <a:endParaRPr lang="en-US" sz="1050" dirty="0">
                        <a:effectLst/>
                        <a:latin typeface="Calibri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cluded 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 major illness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L back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4.2 x 1.5 x 0.8 c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5842766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 panose="020F0502020204030204" pitchFamily="34" charset="0"/>
                        </a:rPr>
                        <a:t>HBM845.MJNG.266</a:t>
                      </a:r>
                      <a:endParaRPr lang="en-US" sz="1050" dirty="0">
                        <a:effectLst/>
                        <a:latin typeface="Calibri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dirty="0"/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Unknown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abdome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2.8 x 1.2 x 0.7 c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7903341"/>
                  </a:ext>
                </a:extLst>
              </a:tr>
              <a:tr h="1489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 panose="020F0502020204030204" pitchFamily="34" charset="0"/>
                        </a:rPr>
                        <a:t>HBM636.ZSVF.869</a:t>
                      </a:r>
                      <a:endParaRPr lang="en-US" sz="1050" dirty="0">
                        <a:effectLst/>
                        <a:latin typeface="Calibri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clude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ystemic lupus erythematosu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R flank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4.7 x 2.1 x 1.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7913750"/>
                  </a:ext>
                </a:extLst>
              </a:tr>
              <a:tr h="1757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499.VJVR.265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3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L abdome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2.3 x 1.4 x 1.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4065260"/>
                  </a:ext>
                </a:extLst>
              </a:tr>
              <a:tr h="3211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1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BM629.MBTF.679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ld</a:t>
                      </a: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 major illne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4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Caucasi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R superior abdome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+mn-lt"/>
                        </a:rPr>
                        <a:t>2.1 x 1.1 x 0.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097" marR="7097" marT="709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2305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88125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2B9F28-63A1-4978-BE36-DCDE04EC9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6A5BD-C011-4A45-AA3A-201790FB7F2B}" type="slidenum">
              <a:rPr lang="en-CA" smtClean="0"/>
              <a:t>3</a:t>
            </a:fld>
            <a:endParaRPr lang="en-CA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7565CD5-FA44-4933-8F73-1F343E0D45A3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628650" y="0"/>
            <a:ext cx="6748463" cy="685800"/>
          </a:xfrm>
        </p:spPr>
        <p:txBody>
          <a:bodyPr>
            <a:normAutofit/>
          </a:bodyPr>
          <a:lstStyle/>
          <a:p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Table S2: 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DICOM Header for the micro CT imag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0405685-EE65-41A0-B2C0-43483C6351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0391" y="603513"/>
            <a:ext cx="6283687" cy="4388350"/>
          </a:xfrm>
          <a:prstGeom prst="rect">
            <a:avLst/>
          </a:prstGeom>
          <a:ln w="19050">
            <a:solidFill>
              <a:schemeClr val="bg2">
                <a:lumMod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170230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1535129-B4E4-4470-BD48-DDC2D7D4B9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7470409"/>
              </p:ext>
            </p:extLst>
          </p:nvPr>
        </p:nvGraphicFramePr>
        <p:xfrm>
          <a:off x="204082" y="340014"/>
          <a:ext cx="8735835" cy="45930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55540">
                  <a:extLst>
                    <a:ext uri="{9D8B030D-6E8A-4147-A177-3AD203B41FA5}">
                      <a16:colId xmlns:a16="http://schemas.microsoft.com/office/drawing/2014/main" val="162138300"/>
                    </a:ext>
                  </a:extLst>
                </a:gridCol>
                <a:gridCol w="1693710">
                  <a:extLst>
                    <a:ext uri="{9D8B030D-6E8A-4147-A177-3AD203B41FA5}">
                      <a16:colId xmlns:a16="http://schemas.microsoft.com/office/drawing/2014/main" val="1624882714"/>
                    </a:ext>
                  </a:extLst>
                </a:gridCol>
                <a:gridCol w="829127">
                  <a:extLst>
                    <a:ext uri="{9D8B030D-6E8A-4147-A177-3AD203B41FA5}">
                      <a16:colId xmlns:a16="http://schemas.microsoft.com/office/drawing/2014/main" val="1788328800"/>
                    </a:ext>
                  </a:extLst>
                </a:gridCol>
                <a:gridCol w="829127">
                  <a:extLst>
                    <a:ext uri="{9D8B030D-6E8A-4147-A177-3AD203B41FA5}">
                      <a16:colId xmlns:a16="http://schemas.microsoft.com/office/drawing/2014/main" val="3659224950"/>
                    </a:ext>
                  </a:extLst>
                </a:gridCol>
                <a:gridCol w="940950">
                  <a:extLst>
                    <a:ext uri="{9D8B030D-6E8A-4147-A177-3AD203B41FA5}">
                      <a16:colId xmlns:a16="http://schemas.microsoft.com/office/drawing/2014/main" val="2356802026"/>
                    </a:ext>
                  </a:extLst>
                </a:gridCol>
                <a:gridCol w="829127">
                  <a:extLst>
                    <a:ext uri="{9D8B030D-6E8A-4147-A177-3AD203B41FA5}">
                      <a16:colId xmlns:a16="http://schemas.microsoft.com/office/drawing/2014/main" val="1945919939"/>
                    </a:ext>
                  </a:extLst>
                </a:gridCol>
                <a:gridCol w="829127">
                  <a:extLst>
                    <a:ext uri="{9D8B030D-6E8A-4147-A177-3AD203B41FA5}">
                      <a16:colId xmlns:a16="http://schemas.microsoft.com/office/drawing/2014/main" val="1213103915"/>
                    </a:ext>
                  </a:extLst>
                </a:gridCol>
                <a:gridCol w="829127">
                  <a:extLst>
                    <a:ext uri="{9D8B030D-6E8A-4147-A177-3AD203B41FA5}">
                      <a16:colId xmlns:a16="http://schemas.microsoft.com/office/drawing/2014/main" val="2255342432"/>
                    </a:ext>
                  </a:extLst>
                </a:gridCol>
              </a:tblGrid>
              <a:tr h="3255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Target Name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Category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Clonality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Vendor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Catalog Number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Staining concentration (ug/mL)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Conjugate/Format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RRID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4919588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 </a:t>
                      </a:r>
                      <a:r>
                        <a:rPr lang="en-US" sz="850" b="1" u="none" strike="noStrike" dirty="0" err="1">
                          <a:effectLst/>
                        </a:rPr>
                        <a:t>pan_Cytokeratin</a:t>
                      </a:r>
                      <a:r>
                        <a:rPr lang="en-US" sz="850" b="1" u="none" strike="noStrike" dirty="0">
                          <a:effectLst/>
                        </a:rPr>
                        <a:t> (1, 5, 6A, 6B, 6C, 8)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pithelial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PCK-2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Sigma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5992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2.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47682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0350903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 </a:t>
                      </a:r>
                      <a:r>
                        <a:rPr lang="en-US" sz="850" b="1" u="none" strike="noStrike" dirty="0" err="1">
                          <a:effectLst/>
                        </a:rPr>
                        <a:t>pan_Cytokeratin</a:t>
                      </a:r>
                      <a:r>
                        <a:rPr lang="en-US" sz="850" b="1" u="none" strike="noStrike" dirty="0">
                          <a:effectLst/>
                        </a:rPr>
                        <a:t> (10, 14, 15, 16, 19)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pithelial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E1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 err="1">
                          <a:effectLst/>
                        </a:rPr>
                        <a:t>Thermo</a:t>
                      </a:r>
                      <a:r>
                        <a:rPr lang="en-US" sz="850" u="none" strike="noStrike" dirty="0">
                          <a:effectLst/>
                        </a:rPr>
                        <a:t> Fisher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14-9001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2.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1834477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4820557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CD3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 T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F7.2.38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Dako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M725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63116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23797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CD31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ndothelial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89C2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ell Signaling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3528BF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160882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0233453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CD4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Helper T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PR685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cam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181724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864377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2115143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CD68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Macrophages and dendritic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KP1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cam </a:t>
                      </a:r>
                      <a:endParaRPr lang="en-US" sz="8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233172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2.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720551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5502045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CD8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totoxic T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8/144B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Dako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M710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075537 </a:t>
                      </a:r>
                      <a:endParaRPr lang="en-US" sz="8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6976442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Collagen IV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xtracellular matrix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IV-4H12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Millipore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MAB3326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22970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8195791"/>
                  </a:ext>
                </a:extLst>
              </a:tr>
              <a:tr h="169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DDB2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UV damage/aging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PR9811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cam </a:t>
                      </a:r>
                      <a:endParaRPr lang="en-US" sz="8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18113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6.2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 secondary detection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88987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7665034"/>
                  </a:ext>
                </a:extLst>
              </a:tr>
              <a:tr h="108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Fibronectin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xtracellular matrix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F1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cam </a:t>
                      </a:r>
                      <a:endParaRPr lang="en-US" sz="8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206928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732380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8732826"/>
                  </a:ext>
                </a:extLst>
              </a:tr>
              <a:tr h="108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FoxP3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Regulatory T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206D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 err="1">
                          <a:effectLst/>
                        </a:rPr>
                        <a:t>Biolegend</a:t>
                      </a:r>
                      <a:endParaRPr lang="en-US" sz="850" b="0" i="0" u="none" strike="noStrike" dirty="0" err="1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32011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10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lexa647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43975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010750"/>
                  </a:ext>
                </a:extLst>
              </a:tr>
              <a:tr h="1110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Ki67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Proliferating cell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SP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cam </a:t>
                      </a:r>
                      <a:endParaRPr lang="en-US" sz="8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197547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60162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8802448"/>
                  </a:ext>
                </a:extLst>
              </a:tr>
              <a:tr h="1110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</a:t>
                      </a:r>
                      <a:r>
                        <a:rPr lang="en-US" sz="850" b="1" u="none" strike="noStrike" dirty="0" err="1">
                          <a:effectLst/>
                        </a:rPr>
                        <a:t>NaKATPase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ell membrane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EP1845Y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cam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167390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991679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3527516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p53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ell cycle regulation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7F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ell Signaling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2527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220662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49438"/>
                  </a:ext>
                </a:extLst>
              </a:tr>
              <a:tr h="217038">
                <a:tc>
                  <a:txBody>
                    <a:bodyPr/>
                    <a:lstStyle/>
                    <a:p>
                      <a:pPr algn="ctr" fontAlgn="b"/>
                      <a:r>
                        <a:rPr lang="it-IT" sz="850" b="1" u="none" strike="noStrike" dirty="0">
                          <a:effectLst/>
                        </a:rPr>
                        <a:t>anti-pan </a:t>
                      </a:r>
                      <a:r>
                        <a:rPr lang="it-IT" sz="850" b="1" u="none" strike="noStrike" dirty="0" err="1">
                          <a:effectLst/>
                        </a:rPr>
                        <a:t>Cadherin</a:t>
                      </a:r>
                      <a:r>
                        <a:rPr lang="it-IT" sz="850" b="1" u="none" strike="noStrike" dirty="0">
                          <a:effectLst/>
                        </a:rPr>
                        <a:t> (1-13, 15-20, 22-24)</a:t>
                      </a:r>
                      <a:endParaRPr lang="it-IT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ell membrane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polyclonal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 err="1">
                          <a:effectLst/>
                        </a:rPr>
                        <a:t>Thermo</a:t>
                      </a:r>
                      <a:r>
                        <a:rPr lang="en-US" sz="850" u="none" strike="noStrike" dirty="0">
                          <a:effectLst/>
                        </a:rPr>
                        <a:t> Fisher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RB-903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14984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6770363"/>
                  </a:ext>
                </a:extLst>
              </a:tr>
              <a:tr h="3255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PGP9.5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Nerve bundles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13C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Santa </a:t>
                      </a:r>
                      <a:r>
                        <a:rPr lang="en-US" sz="850" u="none" strike="noStrike" dirty="0" err="1">
                          <a:effectLst/>
                        </a:rPr>
                        <a:t>cruz</a:t>
                      </a:r>
                      <a:endParaRPr lang="en-US" sz="850" b="0" i="0" u="none" strike="noStrike" dirty="0" err="1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sc-5859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 secondary detection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793620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2956568"/>
                  </a:ext>
                </a:extLst>
              </a:tr>
              <a:tr h="5425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SMA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Lineage marker for smooth muscle cells, multiple cell types (fibroblasts) and structures (vasculature)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1A4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Sigma 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6198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2.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y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47685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8883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b="1" u="none" strike="noStrike" dirty="0">
                          <a:effectLst/>
                        </a:rPr>
                        <a:t>anti-Vimentin</a:t>
                      </a:r>
                      <a:endParaRPr lang="en-US" sz="8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Pan-mesenchymal cell marker, stromal cells, fibroblasts, melanocytes </a:t>
                      </a:r>
                      <a:endParaRPr lang="en-US" sz="8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D21H3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Cell Signaling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9856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1.25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lexa647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50" u="none" strike="noStrike" dirty="0">
                          <a:effectLst/>
                        </a:rPr>
                        <a:t>AB_10834530</a:t>
                      </a:r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1161803"/>
                  </a:ext>
                </a:extLst>
              </a:tr>
            </a:tbl>
          </a:graphicData>
        </a:graphic>
      </p:graphicFrame>
      <p:sp>
        <p:nvSpPr>
          <p:cNvPr id="3" name="Title 1">
            <a:extLst>
              <a:ext uri="{FF2B5EF4-FFF2-40B4-BE49-F238E27FC236}">
                <a16:creationId xmlns:a16="http://schemas.microsoft.com/office/drawing/2014/main" id="{0B70239D-3F9B-45E5-B824-D3BC474BA4D6}"/>
              </a:ext>
            </a:extLst>
          </p:cNvPr>
          <p:cNvSpPr txBox="1">
            <a:spLocks/>
          </p:cNvSpPr>
          <p:nvPr/>
        </p:nvSpPr>
        <p:spPr>
          <a:xfrm>
            <a:off x="110399" y="49241"/>
            <a:ext cx="7829599" cy="909951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buClrTx/>
              <a:buFontTx/>
            </a:pPr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Table S3 – 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Skin Biomarker and antibody information</a:t>
            </a:r>
          </a:p>
        </p:txBody>
      </p:sp>
    </p:spTree>
    <p:extLst>
      <p:ext uri="{BB962C8B-B14F-4D97-AF65-F5344CB8AC3E}">
        <p14:creationId xmlns:p14="http://schemas.microsoft.com/office/powerpoint/2010/main" val="1871706726"/>
      </p:ext>
    </p:extLst>
  </p:cSld>
  <p:clrMapOvr>
    <a:masterClrMapping/>
  </p:clrMapOvr>
</p:sld>
</file>

<file path=ppt/theme/theme1.xml><?xml version="1.0" encoding="utf-8"?>
<a:theme xmlns:a="http://schemas.openxmlformats.org/drawingml/2006/main" name="Swiss">
  <a:themeElements>
    <a:clrScheme name="HuBMAP">
      <a:dk1>
        <a:srgbClr val="444A65"/>
      </a:dk1>
      <a:lt1>
        <a:srgbClr val="FFFFFF"/>
      </a:lt1>
      <a:dk2>
        <a:srgbClr val="2F3346"/>
      </a:dk2>
      <a:lt2>
        <a:srgbClr val="828282"/>
      </a:lt2>
      <a:accent1>
        <a:srgbClr val="444A65"/>
      </a:accent1>
      <a:accent2>
        <a:srgbClr val="828282"/>
      </a:accent2>
      <a:accent3>
        <a:srgbClr val="265A92"/>
      </a:accent3>
      <a:accent4>
        <a:srgbClr val="D25435"/>
      </a:accent4>
      <a:accent5>
        <a:srgbClr val="3781D1"/>
      </a:accent5>
      <a:accent6>
        <a:srgbClr val="FFAE88"/>
      </a:accent6>
      <a:hlink>
        <a:srgbClr val="DB765D"/>
      </a:hlink>
      <a:folHlink>
        <a:srgbClr val="0277B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53</TotalTime>
  <Words>650</Words>
  <Application>Microsoft Office PowerPoint</Application>
  <PresentationFormat>On-screen Show (16:9)</PresentationFormat>
  <Paragraphs>28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Inter</vt:lpstr>
      <vt:lpstr>Lato</vt:lpstr>
      <vt:lpstr>Calibri Light</vt:lpstr>
      <vt:lpstr>Swiss</vt:lpstr>
      <vt:lpstr>Office Theme</vt:lpstr>
      <vt:lpstr>Supplementary Tables  Ghose, Ju et al Human Digital Twin: Automated Cell Type Distance Computation and 3D Atlas Construction in Multiplexed Skin Biopsies</vt:lpstr>
      <vt:lpstr>Supplementary Table S1:  Patient summary and sample location </vt:lpstr>
      <vt:lpstr>Supplementary Table S2: DICOM Header for the micro CT images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uBMAP Data Analysis &amp; Visualization Days December 14-15, 2020</dc:title>
  <dc:creator>Ginty, Fiona (GE Research, US)</dc:creator>
  <cp:lastModifiedBy>Ginty, Fiona (GE Research, US)</cp:lastModifiedBy>
  <cp:revision>807</cp:revision>
  <dcterms:created xsi:type="dcterms:W3CDTF">2020-12-14T22:27:25Z</dcterms:created>
  <dcterms:modified xsi:type="dcterms:W3CDTF">2022-03-28T21:19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7b8a39c-8451-4751-b762-d544d8dbac65_Enabled">
    <vt:lpwstr>False</vt:lpwstr>
  </property>
  <property fmtid="{D5CDD505-2E9C-101B-9397-08002B2CF9AE}" pid="3" name="MSIP_Label_f7b8a39c-8451-4751-b762-d544d8dbac65_SiteId">
    <vt:lpwstr>Local</vt:lpwstr>
  </property>
  <property fmtid="{D5CDD505-2E9C-101B-9397-08002B2CF9AE}" pid="4" name="MSIP_Label_f7b8a39c-8451-4751-b762-d544d8dbac65_Owner">
    <vt:lpwstr>200013327@ge.com</vt:lpwstr>
  </property>
  <property fmtid="{D5CDD505-2E9C-101B-9397-08002B2CF9AE}" pid="5" name="MSIP_Label_f7b8a39c-8451-4751-b762-d544d8dbac65_SetDate">
    <vt:lpwstr>2021-08-05T22:02:11.2265773Z</vt:lpwstr>
  </property>
  <property fmtid="{D5CDD505-2E9C-101B-9397-08002B2CF9AE}" pid="6" name="MSIP_Label_f7b8a39c-8451-4751-b762-d544d8dbac65_Name">
    <vt:lpwstr>GE Highly Confidential</vt:lpwstr>
  </property>
  <property fmtid="{D5CDD505-2E9C-101B-9397-08002B2CF9AE}" pid="7" name="MSIP_Label_f7b8a39c-8451-4751-b762-d544d8dbac65_Application">
    <vt:lpwstr>Microsoft Azure Information Protection</vt:lpwstr>
  </property>
  <property fmtid="{D5CDD505-2E9C-101B-9397-08002B2CF9AE}" pid="8" name="MSIP_Label_f7b8a39c-8451-4751-b762-d544d8dbac65_Extended_MSFT_Method">
    <vt:lpwstr>Manual</vt:lpwstr>
  </property>
</Properties>
</file>